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handoutMasterIdLst>
    <p:handoutMasterId r:id="rId4"/>
  </p:handoutMasterIdLst>
  <p:sldIdLst>
    <p:sldId id="268" r:id="rId2"/>
    <p:sldId id="256" r:id="rId3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zione senza titolo" id="{E9B431BD-7686-48DE-9E22-5A0C2CB67E18}">
          <p14:sldIdLst>
            <p14:sldId id="268"/>
            <p14:sldId id="25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1002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60" cy="498056"/>
          </a:xfrm>
          <a:prstGeom prst="rect">
            <a:avLst/>
          </a:prstGeom>
        </p:spPr>
        <p:txBody>
          <a:bodyPr vert="horz" lIns="92265" tIns="46133" rIns="92265" bIns="4613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850444" y="0"/>
            <a:ext cx="2945660" cy="498056"/>
          </a:xfrm>
          <a:prstGeom prst="rect">
            <a:avLst/>
          </a:prstGeom>
        </p:spPr>
        <p:txBody>
          <a:bodyPr vert="horz" lIns="92265" tIns="46133" rIns="92265" bIns="46133" rtlCol="0"/>
          <a:lstStyle>
            <a:lvl1pPr algn="r">
              <a:defRPr sz="1200"/>
            </a:lvl1pPr>
          </a:lstStyle>
          <a:p>
            <a:fld id="{63B2EE53-D4F9-43AA-AF11-0E60E73C24BD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1" y="9428584"/>
            <a:ext cx="2945660" cy="498055"/>
          </a:xfrm>
          <a:prstGeom prst="rect">
            <a:avLst/>
          </a:prstGeom>
        </p:spPr>
        <p:txBody>
          <a:bodyPr vert="horz" lIns="92265" tIns="46133" rIns="92265" bIns="4613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850444" y="9428584"/>
            <a:ext cx="2945660" cy="498055"/>
          </a:xfrm>
          <a:prstGeom prst="rect">
            <a:avLst/>
          </a:prstGeom>
        </p:spPr>
        <p:txBody>
          <a:bodyPr vert="horz" lIns="92265" tIns="46133" rIns="92265" bIns="46133" rtlCol="0" anchor="b"/>
          <a:lstStyle>
            <a:lvl1pPr algn="r">
              <a:defRPr sz="1200"/>
            </a:lvl1pPr>
          </a:lstStyle>
          <a:p>
            <a:fld id="{FDB0E0C8-FB5C-45D2-9867-11D15A9E936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41313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838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055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548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463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074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801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83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090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311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01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562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88C6E-EF50-4371-9F1B-FF62411508F4}" type="datetimeFigureOut">
              <a:rPr lang="en-US" smtClean="0"/>
              <a:t>1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FADF4-636A-4849-8919-6DB3B592BF1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101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324715" y="510430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350"/>
          </a:p>
        </p:txBody>
      </p:sp>
      <p:sp>
        <p:nvSpPr>
          <p:cNvPr id="19" name="Rettangolo 18"/>
          <p:cNvSpPr/>
          <p:nvPr/>
        </p:nvSpPr>
        <p:spPr>
          <a:xfrm>
            <a:off x="495174" y="6046192"/>
            <a:ext cx="854183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 miRNAs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h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-tissue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file and blood profile on the discovery cohort by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84 cardiac-related array (Log2FC, mean ±SEM).</a:t>
            </a:r>
            <a:endParaRPr lang="en-US" sz="1200" i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2201753" y="332678"/>
            <a:ext cx="4238060" cy="5519838"/>
            <a:chOff x="2201753" y="332678"/>
            <a:chExt cx="4238060" cy="5519838"/>
          </a:xfrm>
        </p:grpSpPr>
        <p:grpSp>
          <p:nvGrpSpPr>
            <p:cNvPr id="15" name="Gruppo 14"/>
            <p:cNvGrpSpPr/>
            <p:nvPr/>
          </p:nvGrpSpPr>
          <p:grpSpPr>
            <a:xfrm>
              <a:off x="2201753" y="332678"/>
              <a:ext cx="4190365" cy="2811780"/>
              <a:chOff x="0" y="0"/>
              <a:chExt cx="4190476" cy="2812348"/>
            </a:xfrm>
          </p:grpSpPr>
          <p:pic>
            <p:nvPicPr>
              <p:cNvPr id="16" name="Immagine 15"/>
              <p:cNvPicPr>
                <a:picLocks noChangeAspect="1"/>
              </p:cNvPicPr>
              <p:nvPr/>
            </p:nvPicPr>
            <p:blipFill rotWithShape="1">
              <a:blip r:embed="rId3"/>
              <a:srcRect t="10425"/>
              <a:stretch/>
            </p:blipFill>
            <p:spPr>
              <a:xfrm>
                <a:off x="0" y="253067"/>
                <a:ext cx="4190476" cy="2559281"/>
              </a:xfrm>
              <a:prstGeom prst="rect">
                <a:avLst/>
              </a:prstGeom>
            </p:spPr>
          </p:pic>
          <p:sp>
            <p:nvSpPr>
              <p:cNvPr id="17" name="CasellaDiTesto 7"/>
              <p:cNvSpPr txBox="1"/>
              <p:nvPr/>
            </p:nvSpPr>
            <p:spPr>
              <a:xfrm>
                <a:off x="1631601" y="0"/>
                <a:ext cx="1026795" cy="2308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900" kern="120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C-tissue profile</a:t>
                </a:r>
                <a:endParaRPr lang="en-US" sz="1200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Gruppo 9"/>
            <p:cNvGrpSpPr/>
            <p:nvPr/>
          </p:nvGrpSpPr>
          <p:grpSpPr>
            <a:xfrm>
              <a:off x="2253576" y="3099791"/>
              <a:ext cx="4186237" cy="2752725"/>
              <a:chOff x="2253576" y="3099791"/>
              <a:chExt cx="4186237" cy="2752725"/>
            </a:xfrm>
          </p:grpSpPr>
          <p:graphicFrame>
            <p:nvGraphicFramePr>
              <p:cNvPr id="11" name="Oggetto 1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89717006"/>
                  </p:ext>
                </p:extLst>
              </p:nvPr>
            </p:nvGraphicFramePr>
            <p:xfrm>
              <a:off x="2253576" y="3099791"/>
              <a:ext cx="4186237" cy="27527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213" name="Prism 7" r:id="rId4" imgW="4186578" imgH="2753378" progId="Prism7.Document">
                      <p:embed/>
                    </p:oleObj>
                  </mc:Choice>
                  <mc:Fallback>
                    <p:oleObj name="Prism 7" r:id="rId4" imgW="4186578" imgH="2753378" progId="Prism7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253576" y="3099791"/>
                            <a:ext cx="4186237" cy="27527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CasellaDiTesto 11"/>
              <p:cNvSpPr txBox="1"/>
              <p:nvPr/>
            </p:nvSpPr>
            <p:spPr>
              <a:xfrm>
                <a:off x="3833311" y="3099791"/>
                <a:ext cx="112169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C-blood profile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859128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/>
          <p:cNvGrpSpPr/>
          <p:nvPr/>
        </p:nvGrpSpPr>
        <p:grpSpPr>
          <a:xfrm>
            <a:off x="2249095" y="54936"/>
            <a:ext cx="4421056" cy="6182615"/>
            <a:chOff x="105892" y="300749"/>
            <a:chExt cx="5894741" cy="8243486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1043" y="300749"/>
              <a:ext cx="1071950" cy="7843208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 rotWithShape="1">
            <a:blip r:embed="rId3"/>
            <a:srcRect t="9822"/>
            <a:stretch/>
          </p:blipFill>
          <p:spPr>
            <a:xfrm>
              <a:off x="2115897" y="443102"/>
              <a:ext cx="3884736" cy="2824722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 noChangeAspect="1"/>
            </p:cNvPicPr>
            <p:nvPr/>
          </p:nvPicPr>
          <p:blipFill rotWithShape="1">
            <a:blip r:embed="rId4"/>
            <a:srcRect t="11078"/>
            <a:stretch/>
          </p:blipFill>
          <p:spPr>
            <a:xfrm>
              <a:off x="2115897" y="3255127"/>
              <a:ext cx="3884736" cy="2785393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 rotWithShape="1">
            <a:blip r:embed="rId5"/>
            <a:srcRect t="10708"/>
            <a:stretch/>
          </p:blipFill>
          <p:spPr>
            <a:xfrm>
              <a:off x="2115897" y="5959000"/>
              <a:ext cx="3884736" cy="2585235"/>
            </a:xfrm>
            <a:prstGeom prst="rect">
              <a:avLst/>
            </a:prstGeom>
          </p:spPr>
        </p:pic>
        <p:pic>
          <p:nvPicPr>
            <p:cNvPr id="9" name="Imagen 2" descr="Captura de pantalla 2017-06-04 a las 10.26.44.pn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892" y="8219510"/>
              <a:ext cx="1882252" cy="231920"/>
            </a:xfrm>
            <a:prstGeom prst="rect">
              <a:avLst/>
            </a:prstGeom>
          </p:spPr>
        </p:pic>
        <p:sp>
          <p:nvSpPr>
            <p:cNvPr id="2" name="CasellaDiTesto 1"/>
            <p:cNvSpPr txBox="1"/>
            <p:nvPr/>
          </p:nvSpPr>
          <p:spPr>
            <a:xfrm>
              <a:off x="202131" y="492262"/>
              <a:ext cx="36379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25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2115897" y="443102"/>
              <a:ext cx="36379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25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2115897" y="3317107"/>
              <a:ext cx="36379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25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2115897" y="6055218"/>
              <a:ext cx="363795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25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3594672" y="443102"/>
              <a:ext cx="927187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PKP2-profile</a:t>
              </a: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3594672" y="3201691"/>
              <a:ext cx="927187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DSP-profile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3594672" y="6050127"/>
              <a:ext cx="927187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DSG2-profile</a:t>
              </a:r>
            </a:p>
          </p:txBody>
        </p:sp>
      </p:grpSp>
      <p:sp>
        <p:nvSpPr>
          <p:cNvPr id="18" name="Rettangolo 17"/>
          <p:cNvSpPr/>
          <p:nvPr/>
        </p:nvSpPr>
        <p:spPr>
          <a:xfrm>
            <a:off x="52039" y="6143846"/>
            <a:ext cx="909196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Gene-dependent miRNA analysis. A: </a:t>
            </a:r>
            <a:r>
              <a:rPr lang="en-GB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stergram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the 84 cardiac-related array analysis on the 9 samples divided based on mutated gene; group 1 – PKP2, group 2 – DSP, group 3 – DSG2. B</a:t>
            </a:r>
            <a:r>
              <a:rPr lang="en-GB" sz="1200" i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1200" i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 miRNAs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PKP2 profile. C: DE miRNAs of DSP profile. D: DE miRNAs of DSG2 profile;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g2FC, mean ±SEM.</a:t>
            </a:r>
          </a:p>
        </p:txBody>
      </p:sp>
    </p:spTree>
    <p:extLst>
      <p:ext uri="{BB962C8B-B14F-4D97-AF65-F5344CB8AC3E}">
        <p14:creationId xmlns:p14="http://schemas.microsoft.com/office/powerpoint/2010/main" val="8625933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9</TotalTime>
  <Words>110</Words>
  <Application>Microsoft Office PowerPoint</Application>
  <PresentationFormat>Presentazione su schermo (4:3)</PresentationFormat>
  <Paragraphs>11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ism 7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kellylab</dc:creator>
  <cp:lastModifiedBy>adminlab</cp:lastModifiedBy>
  <cp:revision>116</cp:revision>
  <cp:lastPrinted>2019-04-05T12:46:38Z</cp:lastPrinted>
  <dcterms:created xsi:type="dcterms:W3CDTF">2018-08-24T13:50:27Z</dcterms:created>
  <dcterms:modified xsi:type="dcterms:W3CDTF">2019-09-10T10:44:11Z</dcterms:modified>
</cp:coreProperties>
</file>